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72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523EB4-F977-28BB-04BA-8E93587C89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72484B-66EC-1864-C530-E822527525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C28690-D2A4-032C-86B7-CC05C47B6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FA3C41-D670-372C-C785-E31F85C73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DF67A6-CC13-6BA3-AF17-A323C88A1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23188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F390E7-AC3A-8FEE-9779-2158995963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3F2304-F835-E5C4-5B4B-34C123415D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BAA7DD-7B48-CAEC-B9C9-05945C6AF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A5A052-E1D4-E8BA-E72D-87EBE47C3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6618E3-C21E-E249-3C4B-C34786E22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37745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4C29AA-80FC-5908-76A4-A2A6ACA882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9D2607-EE5D-18CD-C820-700C0E0001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1A2698-A4B5-AD25-25C2-926E98888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DDE751-9C6E-2ED7-8FDB-2432E02D0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8169F2-A117-86C1-20EF-A56BBA268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2764095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176242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25C4EF-0513-8D81-ED62-E6F371D014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C37A51-237A-0E62-53FD-A5CF65152C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B3D8A1-8459-738E-0A1B-15915F200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3BF957-4E7B-532D-85BF-300FA99F7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82236F-C7F2-4151-FBF3-3B9D69852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85509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618B4D-2889-8F24-47B9-8E226C549F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974BC7-0E64-C1E2-9118-20D89662A2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F8A899-632E-810F-B4AD-F956AD0BE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DA835B-3D37-4AB8-3C05-6BB9577AF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6ECAC-796F-9C36-8817-D57E84F87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61411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B68E6-F8FC-16B5-F7AA-3F676999DB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5CA2D8-D9E3-112A-52DA-8E6FAC6293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94042B-2DE4-B1E4-F648-302649114B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D1D6DD-D4BC-0DEB-4176-3527B9943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8BA962-CE2D-FF48-3210-8676F5B6D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C31AF-8ED7-F82C-A2B1-BB1F13062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56048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E3884-8AF5-EE1A-1B0F-83115DA037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057536-B9D4-1A64-5F0F-1BC4867F98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F0428E-D516-2A70-672A-603870CD62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C609AF7-E13B-13FC-E787-725C366728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C798D4-E839-3033-49D7-245816862C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84DB70D-0383-0EF6-1A9A-7D991D13A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F0F14EF-23E3-C4C3-0250-4CB192237A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724B77-55B8-45E0-C64D-42EA8F4F7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8957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E58CE4-8D05-B726-EE2B-FA9F02002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6CE950-4B23-96B4-250E-7074777E8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31B1406-5B16-EAD6-C369-0CDDD0EFF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FDEDFB-2F0C-F179-3571-F6644D988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50311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E9C3E9-EA03-0524-0909-6E8D4F9C3B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C7450F-726A-7566-7BAC-334D8F0D7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097BD0-BC9C-2117-5F8B-6D4CD8B5C8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36767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DA9675-8080-57DE-2EF4-D55D53312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01076B-1A3A-0E82-FAD6-E67EE8A56E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C940E1-0B16-8C9F-16A4-B457D10DF9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4BB952-5E34-BDBC-E52D-535A3D819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DE27C1-7A24-E170-3F84-909B6145B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6DD754-5721-1F92-3E85-861255F26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41146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422580-38DB-E324-0E82-B6602018B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BA9F5B-4C02-80EA-A72E-912DA6D34E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FD33EF-0F45-AE95-3517-B6C2605093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CEEF25-7D63-6120-0BE0-9B5597EE5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D2B47B-575D-43E7-AEE2-2DD8BF503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981F94-07CE-D50A-A6F6-E0B9E695B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49938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82F064B-F691-1DF5-3EFB-2D95F73623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4915CE-F6E4-E00E-99A8-36C063B8C7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5722B6-60D6-36A2-76BD-6676855DD2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29026A-DE5E-4CE8-93FC-6D0396BCB812}" type="datetimeFigureOut">
              <a:rPr lang="sv-SE" smtClean="0"/>
              <a:t>2023-10-16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9A2FF5-F654-F9D2-ABF5-086E8ADECF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EDBDA2-5F24-F459-C955-4743BFE87E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C855F-3C8D-4A65-AAB9-B974964DF3F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54936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video game&#10;&#10;Description automatically generated">
            <a:extLst>
              <a:ext uri="{FF2B5EF4-FFF2-40B4-BE49-F238E27FC236}">
                <a16:creationId xmlns:a16="http://schemas.microsoft.com/office/drawing/2014/main" id="{20DA9E41-E32C-2B2B-1650-0359969D148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18" t="12334" r="18618" b="36615"/>
          <a:stretch/>
        </p:blipFill>
        <p:spPr>
          <a:xfrm>
            <a:off x="4094480" y="1605280"/>
            <a:ext cx="4887044" cy="2743200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Complement dysregulation associated with a genetic variant in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factor H-related protein 5 in atypical hemolytic uremic syndrome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56308" y="1153497"/>
            <a:ext cx="12116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Factor H-related protein 5 has a functional role in the complement system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Aradottir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46703" y="5857726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Factor H-related protein 5 protects rabbit RBCs from complement-mediated hemolysis</a:t>
            </a:r>
            <a:r>
              <a:rPr lang="en-GB" dirty="0">
                <a:solidFill>
                  <a:schemeClr val="bg1"/>
                </a:solidFill>
              </a:rPr>
              <a:t>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36D28E29-FD94-C776-D030-610CA420AF60}"/>
              </a:ext>
            </a:extLst>
          </p:cNvPr>
          <p:cNvSpPr/>
          <p:nvPr/>
        </p:nvSpPr>
        <p:spPr>
          <a:xfrm>
            <a:off x="1881324" y="3621647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omplement phenotype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66DD5B76-37AE-5E22-7076-67519C1BB700}"/>
              </a:ext>
            </a:extLst>
          </p:cNvPr>
          <p:cNvSpPr/>
          <p:nvPr/>
        </p:nvSpPr>
        <p:spPr>
          <a:xfrm>
            <a:off x="1882994" y="2894991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Genotype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1B34281D-70F3-AC8F-A09C-AE41496E34EF}"/>
              </a:ext>
            </a:extLst>
          </p:cNvPr>
          <p:cNvSpPr/>
          <p:nvPr/>
        </p:nvSpPr>
        <p:spPr>
          <a:xfrm>
            <a:off x="9195469" y="1957201"/>
            <a:ext cx="2440800" cy="97215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800" dirty="0">
                <a:solidFill>
                  <a:schemeClr val="bg1"/>
                </a:solidFill>
              </a:rPr>
              <a:t>Variant carriers have low circulating FHR5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0FCCBE79-1ADD-D8CF-218D-9E0F82ECBA8D}"/>
              </a:ext>
            </a:extLst>
          </p:cNvPr>
          <p:cNvSpPr/>
          <p:nvPr/>
        </p:nvSpPr>
        <p:spPr>
          <a:xfrm>
            <a:off x="9224346" y="4088061"/>
            <a:ext cx="2440800" cy="118800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800" dirty="0">
                <a:solidFill>
                  <a:schemeClr val="bg1"/>
                </a:solidFill>
              </a:rPr>
              <a:t>Addition of rFHR5 to patient sera led to decreased </a:t>
            </a:r>
            <a:r>
              <a:rPr lang="en-GB" sz="1800" dirty="0" err="1">
                <a:solidFill>
                  <a:schemeClr val="bg1"/>
                </a:solidFill>
              </a:rPr>
              <a:t>hemolysis</a:t>
            </a:r>
            <a:endParaRPr lang="en-GB" sz="1800" dirty="0">
              <a:solidFill>
                <a:schemeClr val="bg1"/>
              </a:solidFill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1F74FC5-02B8-F7D2-9BED-E6716CE8766A}"/>
              </a:ext>
            </a:extLst>
          </p:cNvPr>
          <p:cNvSpPr txBox="1"/>
          <p:nvPr/>
        </p:nvSpPr>
        <p:spPr>
          <a:xfrm>
            <a:off x="18717" y="2313173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A child with </a:t>
            </a:r>
            <a:r>
              <a:rPr lang="en-GB" sz="2000" dirty="0" err="1"/>
              <a:t>aHUS</a:t>
            </a:r>
            <a:endParaRPr lang="en-GB" sz="2000" dirty="0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EAF62759-A573-5D3C-8680-A51EC965A29C}"/>
              </a:ext>
            </a:extLst>
          </p:cNvPr>
          <p:cNvSpPr/>
          <p:nvPr/>
        </p:nvSpPr>
        <p:spPr>
          <a:xfrm>
            <a:off x="9204559" y="3022330"/>
            <a:ext cx="2440800" cy="97215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dirty="0">
              <a:solidFill>
                <a:schemeClr val="bg1"/>
              </a:solidFill>
            </a:endParaRPr>
          </a:p>
          <a:p>
            <a:pPr algn="ctr"/>
            <a:r>
              <a:rPr lang="en-GB" dirty="0">
                <a:solidFill>
                  <a:schemeClr val="bg1"/>
                </a:solidFill>
              </a:rPr>
              <a:t>The FHR5</a:t>
            </a:r>
            <a:r>
              <a:rPr lang="en-GB" baseline="-25000" dirty="0">
                <a:solidFill>
                  <a:schemeClr val="bg1"/>
                </a:solidFill>
              </a:rPr>
              <a:t>M514R</a:t>
            </a:r>
            <a:r>
              <a:rPr lang="en-GB" dirty="0">
                <a:solidFill>
                  <a:schemeClr val="bg1"/>
                </a:solidFill>
              </a:rPr>
              <a:t> was minimally secreted by transfected cells</a:t>
            </a:r>
            <a:endParaRPr lang="en-GB" baseline="-25000" dirty="0">
              <a:solidFill>
                <a:schemeClr val="bg1"/>
              </a:solidFill>
            </a:endParaRPr>
          </a:p>
          <a:p>
            <a:r>
              <a:rPr lang="en-GB" sz="1800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9422C97B-FC14-9EE5-4423-0897B9486C5C}"/>
              </a:ext>
            </a:extLst>
          </p:cNvPr>
          <p:cNvSpPr txBox="1"/>
          <p:nvPr/>
        </p:nvSpPr>
        <p:spPr>
          <a:xfrm>
            <a:off x="326723" y="4314351"/>
            <a:ext cx="434099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37A"/>
                </a:solidFill>
              </a:rPr>
              <a:t>FHR5 quantification and dimerization</a:t>
            </a:r>
          </a:p>
          <a:p>
            <a:r>
              <a:rPr lang="en-GB" sz="2000" dirty="0">
                <a:solidFill>
                  <a:srgbClr val="00437A"/>
                </a:solidFill>
              </a:rPr>
              <a:t>Functional testing by </a:t>
            </a:r>
            <a:r>
              <a:rPr lang="en-GB" sz="2000" dirty="0" err="1">
                <a:solidFill>
                  <a:srgbClr val="00437A"/>
                </a:solidFill>
              </a:rPr>
              <a:t>hemolytic</a:t>
            </a:r>
            <a:r>
              <a:rPr lang="en-GB" sz="2000" dirty="0">
                <a:solidFill>
                  <a:srgbClr val="00437A"/>
                </a:solidFill>
              </a:rPr>
              <a:t> assay</a:t>
            </a:r>
          </a:p>
          <a:p>
            <a:r>
              <a:rPr lang="en-GB" sz="2000" dirty="0">
                <a:solidFill>
                  <a:srgbClr val="00437A"/>
                </a:solidFill>
              </a:rPr>
              <a:t>Mutagenesis </a:t>
            </a:r>
          </a:p>
          <a:p>
            <a:endParaRPr lang="en-GB" sz="2000" dirty="0">
              <a:solidFill>
                <a:srgbClr val="00437A"/>
              </a:solidFill>
            </a:endParaRPr>
          </a:p>
        </p:txBody>
      </p:sp>
      <p:pic>
        <p:nvPicPr>
          <p:cNvPr id="121" name="Picture 120" descr="A screenshot of a video game&#10;&#10;Description automatically generated">
            <a:extLst>
              <a:ext uri="{FF2B5EF4-FFF2-40B4-BE49-F238E27FC236}">
                <a16:creationId xmlns:a16="http://schemas.microsoft.com/office/drawing/2014/main" id="{E99813E2-07C1-6D4D-9FB3-0349E474CC4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75" t="63947" r="41193"/>
          <a:stretch/>
        </p:blipFill>
        <p:spPr>
          <a:xfrm>
            <a:off x="4312120" y="3859731"/>
            <a:ext cx="3513222" cy="1986549"/>
          </a:xfrm>
          <a:prstGeom prst="rect">
            <a:avLst/>
          </a:prstGeom>
        </p:spPr>
      </p:pic>
      <p:pic>
        <p:nvPicPr>
          <p:cNvPr id="126" name="Picture 125" descr="A yellow and black image of two people and a child&#10;&#10;Description automatically generated">
            <a:extLst>
              <a:ext uri="{FF2B5EF4-FFF2-40B4-BE49-F238E27FC236}">
                <a16:creationId xmlns:a16="http://schemas.microsoft.com/office/drawing/2014/main" id="{A77A9F96-693A-34C8-26ED-7FD00C2EF63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65" t="36880" r="37930" b="35752"/>
          <a:stretch/>
        </p:blipFill>
        <p:spPr>
          <a:xfrm>
            <a:off x="37968" y="2926082"/>
            <a:ext cx="1532637" cy="1328285"/>
          </a:xfrm>
          <a:prstGeom prst="rect">
            <a:avLst/>
          </a:prstGeom>
        </p:spPr>
      </p:pic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CA4B0F17-E979-09F1-8E91-D7A1DA4313C2}"/>
              </a:ext>
            </a:extLst>
          </p:cNvPr>
          <p:cNvCxnSpPr>
            <a:cxnSpLocks/>
          </p:cNvCxnSpPr>
          <p:nvPr/>
        </p:nvCxnSpPr>
        <p:spPr>
          <a:xfrm>
            <a:off x="3799840" y="3556000"/>
            <a:ext cx="360000" cy="36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D0F638E-9DF0-63C3-2143-2AA16564F4FB}"/>
              </a:ext>
            </a:extLst>
          </p:cNvPr>
          <p:cNvCxnSpPr>
            <a:cxnSpLocks/>
          </p:cNvCxnSpPr>
          <p:nvPr/>
        </p:nvCxnSpPr>
        <p:spPr>
          <a:xfrm flipV="1">
            <a:off x="3799840" y="3210560"/>
            <a:ext cx="360000" cy="36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878F81BA-1C01-9459-4E4A-D482A13AE555}"/>
              </a:ext>
            </a:extLst>
          </p:cNvPr>
          <p:cNvCxnSpPr>
            <a:cxnSpLocks/>
          </p:cNvCxnSpPr>
          <p:nvPr/>
        </p:nvCxnSpPr>
        <p:spPr>
          <a:xfrm>
            <a:off x="1412240" y="3545840"/>
            <a:ext cx="360000" cy="36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B35CDCF4-A0C8-DECF-D64C-15F8C9AE7543}"/>
              </a:ext>
            </a:extLst>
          </p:cNvPr>
          <p:cNvCxnSpPr>
            <a:cxnSpLocks/>
          </p:cNvCxnSpPr>
          <p:nvPr/>
        </p:nvCxnSpPr>
        <p:spPr>
          <a:xfrm flipV="1">
            <a:off x="1412240" y="3200400"/>
            <a:ext cx="360000" cy="36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67683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Office PowerPoint</Application>
  <PresentationFormat>Bredbild</PresentationFormat>
  <Paragraphs>17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esentation</vt:lpstr>
    </vt:vector>
  </TitlesOfParts>
  <Company>Lunds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na Aradóttir</dc:creator>
  <cp:lastModifiedBy>Karpman Diana</cp:lastModifiedBy>
  <cp:revision>1</cp:revision>
  <dcterms:created xsi:type="dcterms:W3CDTF">2023-10-16T06:12:48Z</dcterms:created>
  <dcterms:modified xsi:type="dcterms:W3CDTF">2023-10-16T10:29:05Z</dcterms:modified>
</cp:coreProperties>
</file>